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319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Editor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AA600"/>
    <a:srgbClr val="CCCC00"/>
    <a:srgbClr val="DEEBF7"/>
    <a:srgbClr val="FFF2CC"/>
    <a:srgbClr val="23AE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52" autoAdjust="0"/>
    <p:restoredTop sz="95026" autoAdjust="0"/>
  </p:normalViewPr>
  <p:slideViewPr>
    <p:cSldViewPr snapToGrid="0">
      <p:cViewPr varScale="1">
        <p:scale>
          <a:sx n="94" d="100"/>
          <a:sy n="94" d="100"/>
        </p:scale>
        <p:origin x="53" y="16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EAD75-2861-46B5-B271-94E289338C1E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BA5E7C-6D03-4E4B-803D-50214F09A2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8673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B8D7EC-8869-F1F2-733B-49E0D3C460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4682CA7-F493-CB1B-4B29-9395CDD79D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15B12F-8FB3-90A5-AC1B-EBC29C39D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EC35E6-AFEC-5E8C-D6EA-0F3818E4E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35EEDE-76A1-8FA1-CFCC-BD2FE981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32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87585B-9D2E-07D9-EAD6-77354E967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F6C340C-90FD-BC3E-916F-5D3956F02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F1FE20-16A5-0744-264C-C4C8BB4A8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C5C6BF-0F13-DD08-1149-6014C3D39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71B185-EF77-AE01-9EE8-483952D73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6892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CD7E616-CA2C-469E-F87F-3AF84B2434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985EBD8-6527-4FD9-13C2-06CA3E6C9E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FA87AB-9223-497D-CAAE-1F91B2E78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A04058-6F88-7D2C-E7AA-DEE7F92CA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4E643C-EB07-8A71-6B8B-85A7055CC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16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56A4A5-EDC9-3792-D1D6-86A9826E8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EFDA94-E1CF-9463-2B1C-F9027802F3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6C9A4F-4D48-1BB9-9DBC-08319E26E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33889E-C6ED-41DC-A1F2-C0789C37A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404357-68D5-F60F-1BB8-E522FB290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42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383D8C-4DAE-1747-F0D4-2354911A09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B607418-1614-9D18-01FF-DD949BB5C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60C042-5B7A-DCA8-4B8A-81BE31D7F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A5A1F-6B8F-84ED-6092-F803D70F6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7EBD8E-74CC-0A79-FC15-BA30F5525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101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6467E2-F063-0C2F-4DC5-E646A67B9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89E651-D9DC-9EAC-96FB-5995CE56CD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79C763-2809-6446-98C3-06E6CCA99A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E56D5D-45F3-064E-2EA8-C2CC37A4B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0DCE14-0CAF-A800-954F-9433CFF07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0EF431-DF75-B19C-4567-E85E00A89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154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691D16-F25A-6348-D6B5-E9E233EE08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A2A4AC-A6BB-4BAB-C47E-B01378F1E3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7873B1-51A3-C24A-BFBC-FCCD6EF40B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78B1979-C114-BECA-42D2-87110B4926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48C2C7-0D64-3781-7C9F-4CB25E5D61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8A9C1CB-055D-FFCE-EA2F-F549B89EA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7CAE3D-1377-30C5-1FEA-D055D1EE2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411C6E3-08CF-D0AF-209B-E06FC95F5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245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3AEC6F-996C-4C1B-334B-0D530220A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2E97CC9-827F-9FC9-8104-4E739FAFA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03D317C-7E06-1DC9-567B-A275CD52D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CB2E444-B04F-0E56-0647-86558B0EF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106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91FF394-E568-E673-4A6B-53B73F8CA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2DCDE87-DFD1-BB97-4D00-8EDAC98A8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6469099-2B8F-70CA-198D-62ED40B27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719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A0C9F3-62DF-8B38-D296-698AB86D1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66D345B-42A7-C1C7-0A69-D82FA44190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DBB397B-E961-DE45-535A-DB8BDF840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AF9751D-D3B4-1F7D-CCD4-89C93068F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38FB17-F46C-1152-A1F4-155F4CF9C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A75227-055F-88E6-0434-596523E5E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950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AB0B4-C3C1-BCF6-ADC0-0AAF04FA8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AC322AF-0F32-EBC9-06B3-3ADA053C9D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EB94D42-3072-A261-296C-201A6D513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221AA9-F778-0BAA-8CBA-BD133877C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7EC707-9799-1E16-0283-59DA68E96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171D2B6-612C-D59D-D4D0-6362A2BD5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287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24F115-F37D-804A-423A-A9E1CE687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3DB051-1565-E33B-68C4-35844E4639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418066-14A9-4906-4316-59F2E932FE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749B52-43DE-4223-822E-620C665BEFDA}" type="datetimeFigureOut">
              <a:rPr kumimoji="1" lang="ja-JP" altLang="en-US" smtClean="0"/>
              <a:t>2025/7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84AD7D-5FA7-A08B-75A7-CB519FBCCE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1D7B47-14D5-3115-F5E3-9A387047EB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612E1E-3B43-408F-961A-18C5D8F2C3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00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9D9596-292A-691C-5E9B-42D7E5735A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5C1B6E9-D0E1-1163-CB59-F9E427F87F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6295" y="1470120"/>
            <a:ext cx="3602727" cy="220583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CC9AF29-6E3D-CB0D-26C3-1726C9893E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6295" y="4272220"/>
            <a:ext cx="3602727" cy="222789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2835839-37B9-8677-3BB2-1464C472BDE1}"/>
              </a:ext>
            </a:extLst>
          </p:cNvPr>
          <p:cNvSpPr txBox="1"/>
          <p:nvPr/>
        </p:nvSpPr>
        <p:spPr>
          <a:xfrm>
            <a:off x="7119287" y="3896672"/>
            <a:ext cx="34754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ja-JP" sz="20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mary portal vein branch area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17477D5-9B22-8F7A-55FF-23A5A1CC6221}"/>
              </a:ext>
            </a:extLst>
          </p:cNvPr>
          <p:cNvSpPr txBox="1"/>
          <p:nvPr/>
        </p:nvSpPr>
        <p:spPr>
          <a:xfrm>
            <a:off x="7119287" y="1100788"/>
            <a:ext cx="3214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ja-JP" sz="200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tal vein </a:t>
            </a:r>
            <a:r>
              <a:rPr lang="en-US" altLang="ja-JP" sz="2000" i="0" dirty="0">
                <a:effectLst/>
                <a:latin typeface="BlinkMacSystemFont"/>
              </a:rPr>
              <a:t>trunk branch </a:t>
            </a:r>
            <a:r>
              <a:rPr lang="en-US" altLang="ja-JP" sz="20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rea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B79712F-61C2-B7DF-4063-7A889B299757}"/>
              </a:ext>
            </a:extLst>
          </p:cNvPr>
          <p:cNvSpPr txBox="1"/>
          <p:nvPr/>
        </p:nvSpPr>
        <p:spPr>
          <a:xfrm>
            <a:off x="2404265" y="1100788"/>
            <a:ext cx="20903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kumimoji="1" lang="en-US" altLang="ja-JP" sz="2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rihilar</a:t>
            </a:r>
            <a:r>
              <a:rPr kumimoji="1"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ype HCC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25D9E91-024C-A011-4A66-287D04EE9701}"/>
              </a:ext>
            </a:extLst>
          </p:cNvPr>
          <p:cNvSpPr txBox="1"/>
          <p:nvPr/>
        </p:nvSpPr>
        <p:spPr>
          <a:xfrm>
            <a:off x="2404265" y="3904975"/>
            <a:ext cx="17992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kumimoji="1"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tal-type HCC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05525D1-E173-1832-45DE-4BBFA62D1B2E}"/>
              </a:ext>
            </a:extLst>
          </p:cNvPr>
          <p:cNvSpPr txBox="1"/>
          <p:nvPr/>
        </p:nvSpPr>
        <p:spPr>
          <a:xfrm>
            <a:off x="576050" y="72882"/>
            <a:ext cx="117530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lementary</a:t>
            </a:r>
            <a:r>
              <a:rPr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b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</a:t>
            </a:r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kumimoji="1" lang="ja-JP" alt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kumimoji="1"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lassification of </a:t>
            </a:r>
            <a:r>
              <a:rPr lang="en-US" altLang="ja-JP" sz="1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kumimoji="1" lang="en-US" altLang="ja-JP" sz="1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rihilar-type and </a:t>
            </a:r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stal-type hepatocellular carcinoma (HCC), with further subdivision</a:t>
            </a:r>
            <a:r>
              <a:rPr lang="en-US" altLang="ja-JP" sz="1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perihilar-type </a:t>
            </a:r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CC</a:t>
            </a:r>
            <a:endParaRPr kumimoji="1" lang="ja-JP" altLang="en-US" sz="1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CD614241-8739-50E7-5CD5-4B668A25DE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0193" y="1454326"/>
            <a:ext cx="3535973" cy="2188738"/>
          </a:xfrm>
          <a:prstGeom prst="rect">
            <a:avLst/>
          </a:prstGeom>
        </p:spPr>
      </p:pic>
      <p:sp>
        <p:nvSpPr>
          <p:cNvPr id="20" name="フリーフォーム: 図形 19">
            <a:extLst>
              <a:ext uri="{FF2B5EF4-FFF2-40B4-BE49-F238E27FC236}">
                <a16:creationId xmlns:a16="http://schemas.microsoft.com/office/drawing/2014/main" id="{1C3A0E4B-1C54-07A6-C6A8-0DD1827EA7A3}"/>
              </a:ext>
            </a:extLst>
          </p:cNvPr>
          <p:cNvSpPr/>
          <p:nvPr/>
        </p:nvSpPr>
        <p:spPr>
          <a:xfrm>
            <a:off x="8324801" y="2282716"/>
            <a:ext cx="469431" cy="467272"/>
          </a:xfrm>
          <a:custGeom>
            <a:avLst/>
            <a:gdLst>
              <a:gd name="connsiteX0" fmla="*/ 666977 w 1476605"/>
              <a:gd name="connsiteY0" fmla="*/ 0 h 1501372"/>
              <a:gd name="connsiteX1" fmla="*/ 895974 w 1476605"/>
              <a:gd name="connsiteY1" fmla="*/ 94854 h 1501372"/>
              <a:gd name="connsiteX2" fmla="*/ 912845 w 1476605"/>
              <a:gd name="connsiteY2" fmla="*/ 115302 h 1501372"/>
              <a:gd name="connsiteX3" fmla="*/ 925561 w 1476605"/>
              <a:gd name="connsiteY3" fmla="*/ 111355 h 1501372"/>
              <a:gd name="connsiteX4" fmla="*/ 990828 w 1476605"/>
              <a:gd name="connsiteY4" fmla="*/ 104775 h 1501372"/>
              <a:gd name="connsiteX5" fmla="*/ 1314679 w 1476605"/>
              <a:gd name="connsiteY5" fmla="*/ 428626 h 1501372"/>
              <a:gd name="connsiteX6" fmla="*/ 1308099 w 1476605"/>
              <a:gd name="connsiteY6" fmla="*/ 493893 h 1501372"/>
              <a:gd name="connsiteX7" fmla="*/ 1300537 w 1476605"/>
              <a:gd name="connsiteY7" fmla="*/ 518256 h 1501372"/>
              <a:gd name="connsiteX8" fmla="*/ 1333822 w 1476605"/>
              <a:gd name="connsiteY8" fmla="*/ 536323 h 1501372"/>
              <a:gd name="connsiteX9" fmla="*/ 1476605 w 1476605"/>
              <a:gd name="connsiteY9" fmla="*/ 804865 h 1501372"/>
              <a:gd name="connsiteX10" fmla="*/ 1333822 w 1476605"/>
              <a:gd name="connsiteY10" fmla="*/ 1073407 h 1501372"/>
              <a:gd name="connsiteX11" fmla="*/ 1308296 w 1476605"/>
              <a:gd name="connsiteY11" fmla="*/ 1087263 h 1501372"/>
              <a:gd name="connsiteX12" fmla="*/ 1308099 w 1476605"/>
              <a:gd name="connsiteY12" fmla="*/ 1089208 h 1501372"/>
              <a:gd name="connsiteX13" fmla="*/ 990828 w 1476605"/>
              <a:gd name="connsiteY13" fmla="*/ 1347792 h 1501372"/>
              <a:gd name="connsiteX14" fmla="*/ 879477 w 1476605"/>
              <a:gd name="connsiteY14" fmla="*/ 1328141 h 1501372"/>
              <a:gd name="connsiteX15" fmla="*/ 872779 w 1476605"/>
              <a:gd name="connsiteY15" fmla="*/ 1325016 h 1501372"/>
              <a:gd name="connsiteX16" fmla="*/ 854556 w 1476605"/>
              <a:gd name="connsiteY16" fmla="*/ 1358589 h 1501372"/>
              <a:gd name="connsiteX17" fmla="*/ 586014 w 1476605"/>
              <a:gd name="connsiteY17" fmla="*/ 1501372 h 1501372"/>
              <a:gd name="connsiteX18" fmla="*/ 287613 w 1476605"/>
              <a:gd name="connsiteY18" fmla="*/ 1303578 h 1501372"/>
              <a:gd name="connsiteX19" fmla="*/ 271803 w 1476605"/>
              <a:gd name="connsiteY19" fmla="*/ 1252646 h 1501372"/>
              <a:gd name="connsiteX20" fmla="*/ 258584 w 1476605"/>
              <a:gd name="connsiteY20" fmla="*/ 1251313 h 1501372"/>
              <a:gd name="connsiteX21" fmla="*/ 0 w 1476605"/>
              <a:gd name="connsiteY21" fmla="*/ 934042 h 1501372"/>
              <a:gd name="connsiteX22" fmla="*/ 55309 w 1476605"/>
              <a:gd name="connsiteY22" fmla="*/ 752974 h 1501372"/>
              <a:gd name="connsiteX23" fmla="*/ 81030 w 1476605"/>
              <a:gd name="connsiteY23" fmla="*/ 721800 h 1501372"/>
              <a:gd name="connsiteX24" fmla="*/ 62181 w 1476605"/>
              <a:gd name="connsiteY24" fmla="*/ 694600 h 1501372"/>
              <a:gd name="connsiteX25" fmla="*/ 19275 w 1476605"/>
              <a:gd name="connsiteY25" fmla="*/ 533401 h 1501372"/>
              <a:gd name="connsiteX26" fmla="*/ 343126 w 1476605"/>
              <a:gd name="connsiteY26" fmla="*/ 209550 h 1501372"/>
              <a:gd name="connsiteX27" fmla="*/ 363949 w 1476605"/>
              <a:gd name="connsiteY27" fmla="*/ 212698 h 1501372"/>
              <a:gd name="connsiteX28" fmla="*/ 368576 w 1476605"/>
              <a:gd name="connsiteY28" fmla="*/ 197794 h 1501372"/>
              <a:gd name="connsiteX29" fmla="*/ 666977 w 1476605"/>
              <a:gd name="connsiteY29" fmla="*/ 0 h 15013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</a:cxnLst>
            <a:rect l="l" t="t" r="r" b="b"/>
            <a:pathLst>
              <a:path w="1476605" h="1501372">
                <a:moveTo>
                  <a:pt x="666977" y="0"/>
                </a:moveTo>
                <a:cubicBezTo>
                  <a:pt x="756406" y="0"/>
                  <a:pt x="837369" y="36248"/>
                  <a:pt x="895974" y="94854"/>
                </a:cubicBezTo>
                <a:lnTo>
                  <a:pt x="912845" y="115302"/>
                </a:lnTo>
                <a:lnTo>
                  <a:pt x="925561" y="111355"/>
                </a:lnTo>
                <a:cubicBezTo>
                  <a:pt x="946643" y="107041"/>
                  <a:pt x="968471" y="104775"/>
                  <a:pt x="990828" y="104775"/>
                </a:cubicBezTo>
                <a:cubicBezTo>
                  <a:pt x="1169686" y="104775"/>
                  <a:pt x="1314679" y="249768"/>
                  <a:pt x="1314679" y="428626"/>
                </a:cubicBezTo>
                <a:cubicBezTo>
                  <a:pt x="1314679" y="450983"/>
                  <a:pt x="1312413" y="472811"/>
                  <a:pt x="1308099" y="493893"/>
                </a:cubicBezTo>
                <a:lnTo>
                  <a:pt x="1300537" y="518256"/>
                </a:lnTo>
                <a:lnTo>
                  <a:pt x="1333822" y="536323"/>
                </a:lnTo>
                <a:cubicBezTo>
                  <a:pt x="1419967" y="594521"/>
                  <a:pt x="1476605" y="693079"/>
                  <a:pt x="1476605" y="804865"/>
                </a:cubicBezTo>
                <a:cubicBezTo>
                  <a:pt x="1476605" y="916651"/>
                  <a:pt x="1419967" y="1015209"/>
                  <a:pt x="1333822" y="1073407"/>
                </a:cubicBezTo>
                <a:lnTo>
                  <a:pt x="1308296" y="1087263"/>
                </a:lnTo>
                <a:lnTo>
                  <a:pt x="1308099" y="1089208"/>
                </a:lnTo>
                <a:cubicBezTo>
                  <a:pt x="1277902" y="1236782"/>
                  <a:pt x="1147329" y="1347792"/>
                  <a:pt x="990828" y="1347792"/>
                </a:cubicBezTo>
                <a:cubicBezTo>
                  <a:pt x="951703" y="1347792"/>
                  <a:pt x="914198" y="1340854"/>
                  <a:pt x="879477" y="1328141"/>
                </a:cubicBezTo>
                <a:lnTo>
                  <a:pt x="872779" y="1325016"/>
                </a:lnTo>
                <a:lnTo>
                  <a:pt x="854556" y="1358589"/>
                </a:lnTo>
                <a:cubicBezTo>
                  <a:pt x="796358" y="1444734"/>
                  <a:pt x="697800" y="1501372"/>
                  <a:pt x="586014" y="1501372"/>
                </a:cubicBezTo>
                <a:cubicBezTo>
                  <a:pt x="451871" y="1501372"/>
                  <a:pt x="336776" y="1419813"/>
                  <a:pt x="287613" y="1303578"/>
                </a:cubicBezTo>
                <a:lnTo>
                  <a:pt x="271803" y="1252646"/>
                </a:lnTo>
                <a:lnTo>
                  <a:pt x="258584" y="1251313"/>
                </a:lnTo>
                <a:cubicBezTo>
                  <a:pt x="111010" y="1221116"/>
                  <a:pt x="0" y="1090543"/>
                  <a:pt x="0" y="934042"/>
                </a:cubicBezTo>
                <a:cubicBezTo>
                  <a:pt x="0" y="866970"/>
                  <a:pt x="20390" y="804661"/>
                  <a:pt x="55309" y="752974"/>
                </a:cubicBezTo>
                <a:lnTo>
                  <a:pt x="81030" y="721800"/>
                </a:lnTo>
                <a:lnTo>
                  <a:pt x="62181" y="694600"/>
                </a:lnTo>
                <a:cubicBezTo>
                  <a:pt x="34886" y="647131"/>
                  <a:pt x="19275" y="592089"/>
                  <a:pt x="19275" y="533401"/>
                </a:cubicBezTo>
                <a:cubicBezTo>
                  <a:pt x="19275" y="354543"/>
                  <a:pt x="164268" y="209550"/>
                  <a:pt x="343126" y="209550"/>
                </a:cubicBezTo>
                <a:lnTo>
                  <a:pt x="363949" y="212698"/>
                </a:lnTo>
                <a:lnTo>
                  <a:pt x="368576" y="197794"/>
                </a:lnTo>
                <a:cubicBezTo>
                  <a:pt x="417739" y="81559"/>
                  <a:pt x="532834" y="0"/>
                  <a:pt x="666977" y="0"/>
                </a:cubicBezTo>
                <a:close/>
              </a:path>
            </a:pathLst>
          </a:custGeom>
          <a:gradFill flip="none" rotWithShape="1">
            <a:gsLst>
              <a:gs pos="1000">
                <a:schemeClr val="accent1">
                  <a:lumMod val="5000"/>
                  <a:lumOff val="95000"/>
                </a:schemeClr>
              </a:gs>
              <a:gs pos="54000">
                <a:srgbClr val="6600FF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kumimoji="1" lang="ja-JP" altLang="en-US" sz="135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0C27F37-2EBC-D04B-DA67-4F3109A711F4}"/>
              </a:ext>
            </a:extLst>
          </p:cNvPr>
          <p:cNvSpPr txBox="1"/>
          <p:nvPr/>
        </p:nvSpPr>
        <p:spPr>
          <a:xfrm>
            <a:off x="3864258" y="3259723"/>
            <a:ext cx="1183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rtal vein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C087817A-C2FF-A05B-AC73-8A26E6B537C1}"/>
              </a:ext>
            </a:extLst>
          </p:cNvPr>
          <p:cNvCxnSpPr>
            <a:cxnSpLocks/>
          </p:cNvCxnSpPr>
          <p:nvPr/>
        </p:nvCxnSpPr>
        <p:spPr>
          <a:xfrm>
            <a:off x="5471056" y="2397968"/>
            <a:ext cx="122231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33CF2E43-634B-0EF7-EE05-CCB88C720B22}"/>
              </a:ext>
            </a:extLst>
          </p:cNvPr>
          <p:cNvCxnSpPr>
            <a:cxnSpLocks/>
          </p:cNvCxnSpPr>
          <p:nvPr/>
        </p:nvCxnSpPr>
        <p:spPr>
          <a:xfrm flipH="1">
            <a:off x="6082211" y="2397968"/>
            <a:ext cx="9014" cy="29111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6DB016CB-6FE5-56D3-9981-B7A137C76718}"/>
              </a:ext>
            </a:extLst>
          </p:cNvPr>
          <p:cNvCxnSpPr>
            <a:cxnSpLocks/>
          </p:cNvCxnSpPr>
          <p:nvPr/>
        </p:nvCxnSpPr>
        <p:spPr>
          <a:xfrm>
            <a:off x="6082211" y="5293780"/>
            <a:ext cx="6111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" name="図 3">
            <a:extLst>
              <a:ext uri="{FF2B5EF4-FFF2-40B4-BE49-F238E27FC236}">
                <a16:creationId xmlns:a16="http://schemas.microsoft.com/office/drawing/2014/main" id="{AEC64999-8985-3D4B-922F-F82E4D9E9A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89363" y="4287520"/>
            <a:ext cx="3631908" cy="2127617"/>
          </a:xfrm>
          <a:prstGeom prst="rect">
            <a:avLst/>
          </a:prstGeom>
        </p:spPr>
      </p:pic>
      <p:sp>
        <p:nvSpPr>
          <p:cNvPr id="15" name="フリーフォーム: 図形 14">
            <a:extLst>
              <a:ext uri="{FF2B5EF4-FFF2-40B4-BE49-F238E27FC236}">
                <a16:creationId xmlns:a16="http://schemas.microsoft.com/office/drawing/2014/main" id="{680FCC7B-317D-46AF-8D90-91AA03307301}"/>
              </a:ext>
            </a:extLst>
          </p:cNvPr>
          <p:cNvSpPr/>
          <p:nvPr/>
        </p:nvSpPr>
        <p:spPr>
          <a:xfrm>
            <a:off x="7431650" y="5131654"/>
            <a:ext cx="469431" cy="467272"/>
          </a:xfrm>
          <a:custGeom>
            <a:avLst/>
            <a:gdLst>
              <a:gd name="connsiteX0" fmla="*/ 666977 w 1476605"/>
              <a:gd name="connsiteY0" fmla="*/ 0 h 1501372"/>
              <a:gd name="connsiteX1" fmla="*/ 895974 w 1476605"/>
              <a:gd name="connsiteY1" fmla="*/ 94854 h 1501372"/>
              <a:gd name="connsiteX2" fmla="*/ 912845 w 1476605"/>
              <a:gd name="connsiteY2" fmla="*/ 115302 h 1501372"/>
              <a:gd name="connsiteX3" fmla="*/ 925561 w 1476605"/>
              <a:gd name="connsiteY3" fmla="*/ 111355 h 1501372"/>
              <a:gd name="connsiteX4" fmla="*/ 990828 w 1476605"/>
              <a:gd name="connsiteY4" fmla="*/ 104775 h 1501372"/>
              <a:gd name="connsiteX5" fmla="*/ 1314679 w 1476605"/>
              <a:gd name="connsiteY5" fmla="*/ 428626 h 1501372"/>
              <a:gd name="connsiteX6" fmla="*/ 1308099 w 1476605"/>
              <a:gd name="connsiteY6" fmla="*/ 493893 h 1501372"/>
              <a:gd name="connsiteX7" fmla="*/ 1300537 w 1476605"/>
              <a:gd name="connsiteY7" fmla="*/ 518256 h 1501372"/>
              <a:gd name="connsiteX8" fmla="*/ 1333822 w 1476605"/>
              <a:gd name="connsiteY8" fmla="*/ 536323 h 1501372"/>
              <a:gd name="connsiteX9" fmla="*/ 1476605 w 1476605"/>
              <a:gd name="connsiteY9" fmla="*/ 804865 h 1501372"/>
              <a:gd name="connsiteX10" fmla="*/ 1333822 w 1476605"/>
              <a:gd name="connsiteY10" fmla="*/ 1073407 h 1501372"/>
              <a:gd name="connsiteX11" fmla="*/ 1308296 w 1476605"/>
              <a:gd name="connsiteY11" fmla="*/ 1087263 h 1501372"/>
              <a:gd name="connsiteX12" fmla="*/ 1308099 w 1476605"/>
              <a:gd name="connsiteY12" fmla="*/ 1089208 h 1501372"/>
              <a:gd name="connsiteX13" fmla="*/ 990828 w 1476605"/>
              <a:gd name="connsiteY13" fmla="*/ 1347792 h 1501372"/>
              <a:gd name="connsiteX14" fmla="*/ 879477 w 1476605"/>
              <a:gd name="connsiteY14" fmla="*/ 1328141 h 1501372"/>
              <a:gd name="connsiteX15" fmla="*/ 872779 w 1476605"/>
              <a:gd name="connsiteY15" fmla="*/ 1325016 h 1501372"/>
              <a:gd name="connsiteX16" fmla="*/ 854556 w 1476605"/>
              <a:gd name="connsiteY16" fmla="*/ 1358589 h 1501372"/>
              <a:gd name="connsiteX17" fmla="*/ 586014 w 1476605"/>
              <a:gd name="connsiteY17" fmla="*/ 1501372 h 1501372"/>
              <a:gd name="connsiteX18" fmla="*/ 287613 w 1476605"/>
              <a:gd name="connsiteY18" fmla="*/ 1303578 h 1501372"/>
              <a:gd name="connsiteX19" fmla="*/ 271803 w 1476605"/>
              <a:gd name="connsiteY19" fmla="*/ 1252646 h 1501372"/>
              <a:gd name="connsiteX20" fmla="*/ 258584 w 1476605"/>
              <a:gd name="connsiteY20" fmla="*/ 1251313 h 1501372"/>
              <a:gd name="connsiteX21" fmla="*/ 0 w 1476605"/>
              <a:gd name="connsiteY21" fmla="*/ 934042 h 1501372"/>
              <a:gd name="connsiteX22" fmla="*/ 55309 w 1476605"/>
              <a:gd name="connsiteY22" fmla="*/ 752974 h 1501372"/>
              <a:gd name="connsiteX23" fmla="*/ 81030 w 1476605"/>
              <a:gd name="connsiteY23" fmla="*/ 721800 h 1501372"/>
              <a:gd name="connsiteX24" fmla="*/ 62181 w 1476605"/>
              <a:gd name="connsiteY24" fmla="*/ 694600 h 1501372"/>
              <a:gd name="connsiteX25" fmla="*/ 19275 w 1476605"/>
              <a:gd name="connsiteY25" fmla="*/ 533401 h 1501372"/>
              <a:gd name="connsiteX26" fmla="*/ 343126 w 1476605"/>
              <a:gd name="connsiteY26" fmla="*/ 209550 h 1501372"/>
              <a:gd name="connsiteX27" fmla="*/ 363949 w 1476605"/>
              <a:gd name="connsiteY27" fmla="*/ 212698 h 1501372"/>
              <a:gd name="connsiteX28" fmla="*/ 368576 w 1476605"/>
              <a:gd name="connsiteY28" fmla="*/ 197794 h 1501372"/>
              <a:gd name="connsiteX29" fmla="*/ 666977 w 1476605"/>
              <a:gd name="connsiteY29" fmla="*/ 0 h 15013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</a:cxnLst>
            <a:rect l="l" t="t" r="r" b="b"/>
            <a:pathLst>
              <a:path w="1476605" h="1501372">
                <a:moveTo>
                  <a:pt x="666977" y="0"/>
                </a:moveTo>
                <a:cubicBezTo>
                  <a:pt x="756406" y="0"/>
                  <a:pt x="837369" y="36248"/>
                  <a:pt x="895974" y="94854"/>
                </a:cubicBezTo>
                <a:lnTo>
                  <a:pt x="912845" y="115302"/>
                </a:lnTo>
                <a:lnTo>
                  <a:pt x="925561" y="111355"/>
                </a:lnTo>
                <a:cubicBezTo>
                  <a:pt x="946643" y="107041"/>
                  <a:pt x="968471" y="104775"/>
                  <a:pt x="990828" y="104775"/>
                </a:cubicBezTo>
                <a:cubicBezTo>
                  <a:pt x="1169686" y="104775"/>
                  <a:pt x="1314679" y="249768"/>
                  <a:pt x="1314679" y="428626"/>
                </a:cubicBezTo>
                <a:cubicBezTo>
                  <a:pt x="1314679" y="450983"/>
                  <a:pt x="1312413" y="472811"/>
                  <a:pt x="1308099" y="493893"/>
                </a:cubicBezTo>
                <a:lnTo>
                  <a:pt x="1300537" y="518256"/>
                </a:lnTo>
                <a:lnTo>
                  <a:pt x="1333822" y="536323"/>
                </a:lnTo>
                <a:cubicBezTo>
                  <a:pt x="1419967" y="594521"/>
                  <a:pt x="1476605" y="693079"/>
                  <a:pt x="1476605" y="804865"/>
                </a:cubicBezTo>
                <a:cubicBezTo>
                  <a:pt x="1476605" y="916651"/>
                  <a:pt x="1419967" y="1015209"/>
                  <a:pt x="1333822" y="1073407"/>
                </a:cubicBezTo>
                <a:lnTo>
                  <a:pt x="1308296" y="1087263"/>
                </a:lnTo>
                <a:lnTo>
                  <a:pt x="1308099" y="1089208"/>
                </a:lnTo>
                <a:cubicBezTo>
                  <a:pt x="1277902" y="1236782"/>
                  <a:pt x="1147329" y="1347792"/>
                  <a:pt x="990828" y="1347792"/>
                </a:cubicBezTo>
                <a:cubicBezTo>
                  <a:pt x="951703" y="1347792"/>
                  <a:pt x="914198" y="1340854"/>
                  <a:pt x="879477" y="1328141"/>
                </a:cubicBezTo>
                <a:lnTo>
                  <a:pt x="872779" y="1325016"/>
                </a:lnTo>
                <a:lnTo>
                  <a:pt x="854556" y="1358589"/>
                </a:lnTo>
                <a:cubicBezTo>
                  <a:pt x="796358" y="1444734"/>
                  <a:pt x="697800" y="1501372"/>
                  <a:pt x="586014" y="1501372"/>
                </a:cubicBezTo>
                <a:cubicBezTo>
                  <a:pt x="451871" y="1501372"/>
                  <a:pt x="336776" y="1419813"/>
                  <a:pt x="287613" y="1303578"/>
                </a:cubicBezTo>
                <a:lnTo>
                  <a:pt x="271803" y="1252646"/>
                </a:lnTo>
                <a:lnTo>
                  <a:pt x="258584" y="1251313"/>
                </a:lnTo>
                <a:cubicBezTo>
                  <a:pt x="111010" y="1221116"/>
                  <a:pt x="0" y="1090543"/>
                  <a:pt x="0" y="934042"/>
                </a:cubicBezTo>
                <a:cubicBezTo>
                  <a:pt x="0" y="866970"/>
                  <a:pt x="20390" y="804661"/>
                  <a:pt x="55309" y="752974"/>
                </a:cubicBezTo>
                <a:lnTo>
                  <a:pt x="81030" y="721800"/>
                </a:lnTo>
                <a:lnTo>
                  <a:pt x="62181" y="694600"/>
                </a:lnTo>
                <a:cubicBezTo>
                  <a:pt x="34886" y="647131"/>
                  <a:pt x="19275" y="592089"/>
                  <a:pt x="19275" y="533401"/>
                </a:cubicBezTo>
                <a:cubicBezTo>
                  <a:pt x="19275" y="354543"/>
                  <a:pt x="164268" y="209550"/>
                  <a:pt x="343126" y="209550"/>
                </a:cubicBezTo>
                <a:lnTo>
                  <a:pt x="363949" y="212698"/>
                </a:lnTo>
                <a:lnTo>
                  <a:pt x="368576" y="197794"/>
                </a:lnTo>
                <a:cubicBezTo>
                  <a:pt x="417739" y="81559"/>
                  <a:pt x="532834" y="0"/>
                  <a:pt x="666977" y="0"/>
                </a:cubicBezTo>
                <a:close/>
              </a:path>
            </a:pathLst>
          </a:custGeom>
          <a:gradFill flip="none" rotWithShape="1">
            <a:gsLst>
              <a:gs pos="1000">
                <a:schemeClr val="accent1">
                  <a:lumMod val="5000"/>
                  <a:lumOff val="95000"/>
                </a:schemeClr>
              </a:gs>
              <a:gs pos="54000">
                <a:srgbClr val="6600FF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kumimoji="1" lang="ja-JP" altLang="en-US" sz="1350" dirty="0"/>
          </a:p>
        </p:txBody>
      </p:sp>
      <p:sp>
        <p:nvSpPr>
          <p:cNvPr id="6" name="楕円 5">
            <a:extLst>
              <a:ext uri="{FF2B5EF4-FFF2-40B4-BE49-F238E27FC236}">
                <a16:creationId xmlns:a16="http://schemas.microsoft.com/office/drawing/2014/main" id="{B19986E4-5AD8-FC4A-8B72-AAE123F61DA0}"/>
              </a:ext>
            </a:extLst>
          </p:cNvPr>
          <p:cNvSpPr/>
          <p:nvPr/>
        </p:nvSpPr>
        <p:spPr>
          <a:xfrm>
            <a:off x="10628927" y="3852225"/>
            <a:ext cx="512063" cy="507665"/>
          </a:xfrm>
          <a:prstGeom prst="ellipse">
            <a:avLst/>
          </a:prstGeom>
          <a:solidFill>
            <a:srgbClr val="FFF2CC"/>
          </a:solidFill>
          <a:ln w="9525">
            <a:solidFill>
              <a:schemeClr val="accent2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楕円 6">
            <a:extLst>
              <a:ext uri="{FF2B5EF4-FFF2-40B4-BE49-F238E27FC236}">
                <a16:creationId xmlns:a16="http://schemas.microsoft.com/office/drawing/2014/main" id="{30BF7FAD-0435-CBC3-EC5A-B223821BA73C}"/>
              </a:ext>
            </a:extLst>
          </p:cNvPr>
          <p:cNvSpPr/>
          <p:nvPr/>
        </p:nvSpPr>
        <p:spPr>
          <a:xfrm>
            <a:off x="10399228" y="1047010"/>
            <a:ext cx="512063" cy="507665"/>
          </a:xfrm>
          <a:prstGeom prst="ellipse">
            <a:avLst/>
          </a:prstGeom>
          <a:solidFill>
            <a:srgbClr val="DEEBF7"/>
          </a:solidFill>
          <a:ln w="9525">
            <a:solidFill>
              <a:schemeClr val="accent4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7816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4</TotalTime>
  <Words>36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BlinkMacSystemFont</vt:lpstr>
      <vt:lpstr>Calibri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慶太 槙</dc:creator>
  <cp:lastModifiedBy>MDPI</cp:lastModifiedBy>
  <cp:revision>106</cp:revision>
  <cp:lastPrinted>2025-06-06T02:15:55Z</cp:lastPrinted>
  <dcterms:created xsi:type="dcterms:W3CDTF">2025-02-01T13:02:37Z</dcterms:created>
  <dcterms:modified xsi:type="dcterms:W3CDTF">2025-07-31T13:56:46Z</dcterms:modified>
</cp:coreProperties>
</file>